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6632AC-6F79-4D8A-9A50-476D707480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9B9D6B-CA6D-4EA3-8293-4B29EF0168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46D29E-7C82-47F5-ABEA-193B3E163B2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1CDF86-A8C1-41D4-B1B3-8429CB2B6CE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44BA98-4DFF-4A9A-A70B-8431C72423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976236-C843-471C-ACF1-9C113A9F7D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AF1AEA-970D-4BE7-999F-E30977B1116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EBC52F-637D-4B34-8F0D-CE432F09DA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4B7DFA-1AFB-428B-A7F3-81FB04DCEC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FEE072-757D-4282-8BDC-8851D493B2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1AD8C5-E4FB-489D-95D5-0D60A18FE9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87737C-134D-4928-B406-F598D0590E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3CAE6B-318C-473A-9726-0A0C0E7FF2B3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>
            <a:alpha val="0"/>
          </a:srgbClr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1"/>
          <p:cNvGraphicFramePr/>
          <p:nvPr/>
        </p:nvGraphicFramePr>
        <p:xfrm>
          <a:off x="620640" y="324000"/>
          <a:ext cx="5256360" cy="68468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20640" y="324000"/>
                    <a:ext cx="5256360" cy="6846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Rectangle 1"/>
          <p:cNvSpPr/>
          <p:nvPr/>
        </p:nvSpPr>
        <p:spPr>
          <a:xfrm>
            <a:off x="404640" y="7164360"/>
            <a:ext cx="6193080" cy="157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1199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Supplementary figure 1. Comparative study of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</a:t>
            </a: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rectal temperatures and clinical scores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Mean and SD of rectal temperatures (panel A) and clinical scores (panel B) (y-axis) in the different groups of pigs immunised at different days after immunisation (V), booster (B) and before challenge (C) (x-axis). Pigs were immunised with the deletion mutant Benin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MFG at different doses (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,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and 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4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TCID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Times New Roman"/>
                <a:ea typeface="Calibri"/>
              </a:rPr>
              <a:t>50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) by intramuscular and intranasal route. Differences among groups at different times of the experiment were evaluated statistically (two-way ANOVA with Bonferroni post-test). Asterisks indicate statistically significant differences between groups of pigs (***P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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0.001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Object 1"/>
          <p:cNvGraphicFramePr/>
          <p:nvPr/>
        </p:nvGraphicFramePr>
        <p:xfrm>
          <a:off x="312840" y="1908000"/>
          <a:ext cx="6005520" cy="40672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5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12840" y="1908000"/>
                    <a:ext cx="6005520" cy="4067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6" name="Rectangle 1"/>
          <p:cNvSpPr/>
          <p:nvPr/>
        </p:nvSpPr>
        <p:spPr>
          <a:xfrm>
            <a:off x="284040" y="6372360"/>
            <a:ext cx="6169320" cy="139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1199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Supplementary figure 2. Comparative study of ASFV genome copies in blood samples.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Mean and SD of ASFV genome copies (y-axis) detected by qPCR in EDTA blood samples from all immunised pigs at different days after immunisation (V), booster (B) and before challenge (C) (x-axis). Pigs were immunised with the deletion mutant Benin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MFG at different doses (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,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and 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4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TCID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Times New Roman"/>
                <a:ea typeface="Calibri"/>
              </a:rPr>
              <a:t>50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) by intramuscular and intranasal route. Differences among groups at different times of the experiment were evaluated statistically (two-way ANOVA with Bonferroni post-test). Asterisks indicate statistically significant differences between groups of pigs (***P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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0.001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7" name="Object 1"/>
          <p:cNvGraphicFramePr/>
          <p:nvPr/>
        </p:nvGraphicFramePr>
        <p:xfrm>
          <a:off x="942840" y="324000"/>
          <a:ext cx="4972320" cy="7080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8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942840" y="324000"/>
                    <a:ext cx="4972320" cy="7080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9" name="Rectangle 1"/>
          <p:cNvSpPr/>
          <p:nvPr/>
        </p:nvSpPr>
        <p:spPr>
          <a:xfrm>
            <a:off x="333360" y="7404120"/>
            <a:ext cx="6191280" cy="157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1199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Supplementary figure 3. Comparative study of IgM and IgG concentrations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Mean and SD of IgM and IgG concentrations (y-axis) detected by ELISA in serum samples from all immunised pigs at different days after immunisation (V), booster (B) and after challenge (C) (x-axis). Pigs were immunised with the deletion mutant Benin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MFG at different doses (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2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,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and 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4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TCID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Times New Roman"/>
                <a:ea typeface="Calibri"/>
              </a:rPr>
              <a:t>50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) by intramuscular and intranasal route. Differences among groups at different times of the experiment were evaluated statistically (two-way ANOVA with Bonferroni post-test). Not significant differences were observed among groups throughout the experiment. Optical density (OD) (y-axis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Object 1"/>
          <p:cNvGraphicFramePr/>
          <p:nvPr/>
        </p:nvGraphicFramePr>
        <p:xfrm>
          <a:off x="1268280" y="179280"/>
          <a:ext cx="3838680" cy="7242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1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268280" y="179280"/>
                    <a:ext cx="3838680" cy="7242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2" name="Rectangle 1"/>
          <p:cNvSpPr/>
          <p:nvPr/>
        </p:nvSpPr>
        <p:spPr>
          <a:xfrm>
            <a:off x="333360" y="7421400"/>
            <a:ext cx="6264360" cy="2173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1199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Supplementary figure 4. Comparative study of IFNγ, IL-10 and IL-1β concentrations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Mean and SD of IFNγ, IL-10 and IL-1β concentrations (y-axis) detected by ELISA in serum samples from pigs immunised with 1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Times New Roman"/>
                <a:ea typeface="Calibri"/>
              </a:rPr>
              <a:t>3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TCID</a:t>
            </a:r>
            <a:r>
              <a:rPr b="0" lang="en-GB" sz="1200" spc="-1" strike="noStrike" baseline="-25000">
                <a:solidFill>
                  <a:srgbClr val="000000"/>
                </a:solidFill>
                <a:latin typeface="Times New Roman"/>
                <a:ea typeface="Calibri"/>
              </a:rPr>
              <a:t>50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 by intramuscular (group B) and intranasal (group D) route at different days after immunisation (V), booster (B) and before challenge (C) (x-axis). Differences between both groups at different times of the experiment were evaluated statistically (two-way ANOVA with Bonferroni post-test). Asterisks indicate statistically significant differences between groups of pigs (***P</a:t>
            </a:r>
            <a:r>
              <a:rPr b="0" lang="en-GB" sz="1200" spc="-1" strike="noStrike">
                <a:solidFill>
                  <a:srgbClr val="000000"/>
                </a:solidFill>
                <a:latin typeface="Symbol"/>
                <a:ea typeface="Symbol"/>
              </a:rPr>
              <a:t>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0.001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200000"/>
              </a:lnSpc>
              <a:spcBef>
                <a:spcPts val="1199"/>
              </a:spcBef>
              <a:spcAft>
                <a:spcPts val="6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Calibri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9-01T13:37:07Z</dcterms:created>
  <dc:creator>Sanchez-Cordon, Pedro (APHA)</dc:creator>
  <dc:description/>
  <dc:language>en-US</dc:language>
  <cp:lastModifiedBy>Sanchez-Cordon, Pedro (APHA)</cp:lastModifiedBy>
  <cp:lastPrinted>2017-10-06T09:26:17Z</cp:lastPrinted>
  <dcterms:modified xsi:type="dcterms:W3CDTF">2017-10-12T21:46:21Z</dcterms:modified>
  <cp:revision>46</cp:revision>
  <dc:subject/>
  <dc:title>PowerPoint Presentation</dc:title>
</cp:coreProperties>
</file>